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70" d="100"/>
          <a:sy n="170" d="100"/>
        </p:scale>
        <p:origin x="120" y="-40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855395-D8DF-41A6-8B92-A8A90621BD0D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19219A-A501-438B-AB4A-0E35CADBEF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6272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567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328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134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340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9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675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348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132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275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654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2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154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925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892" indent="0">
              <a:buNone/>
              <a:defRPr sz="900"/>
            </a:lvl2pPr>
            <a:lvl3pPr marL="685783" indent="0">
              <a:buNone/>
              <a:defRPr sz="750"/>
            </a:lvl3pPr>
            <a:lvl4pPr marL="1028675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8" indent="0">
              <a:buNone/>
              <a:defRPr sz="675"/>
            </a:lvl7pPr>
            <a:lvl8pPr marL="2400240" indent="0">
              <a:buNone/>
              <a:defRPr sz="675"/>
            </a:lvl8pPr>
            <a:lvl9pPr marL="2743132" indent="0">
              <a:buNone/>
              <a:defRPr sz="675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007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3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8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892" indent="0">
              <a:buNone/>
              <a:defRPr sz="900"/>
            </a:lvl2pPr>
            <a:lvl3pPr marL="685783" indent="0">
              <a:buNone/>
              <a:defRPr sz="750"/>
            </a:lvl3pPr>
            <a:lvl4pPr marL="1028675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8" indent="0">
              <a:buNone/>
              <a:defRPr sz="675"/>
            </a:lvl7pPr>
            <a:lvl8pPr marL="2400240" indent="0">
              <a:buNone/>
              <a:defRPr sz="675"/>
            </a:lvl8pPr>
            <a:lvl9pPr marL="2743132" indent="0">
              <a:buNone/>
              <a:defRPr sz="675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762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56C25-46D8-4122-B66D-463475C5D29E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0E978A-251F-4FFB-A22A-9C406F59E7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09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783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68" indent="-257168" algn="l" defTabSz="685783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99" indent="-214308" algn="l" defTabSz="685783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2808114" y="176389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ba1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1615124" y="176389"/>
            <a:ext cx="49885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4868646" y="176389"/>
            <a:ext cx="56778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3900348" y="176389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h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085693" y="1454168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S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821197" y="654068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925392" y="2292368"/>
            <a:ext cx="5148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609600" y="3054368"/>
            <a:ext cx="8306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+ PS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978291" y="3892568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668912" y="4730768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 PS</a:t>
            </a:r>
          </a:p>
        </p:txBody>
      </p:sp>
      <p:grpSp>
        <p:nvGrpSpPr>
          <p:cNvPr id="3" name="Gruppieren 2"/>
          <p:cNvGrpSpPr>
            <a:grpSpLocks noChangeAspect="1"/>
          </p:cNvGrpSpPr>
          <p:nvPr/>
        </p:nvGrpSpPr>
        <p:grpSpPr>
          <a:xfrm>
            <a:off x="1396664" y="428596"/>
            <a:ext cx="4242136" cy="4753004"/>
            <a:chOff x="912872" y="209276"/>
            <a:chExt cx="4040128" cy="4526670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2"/>
            <a:srcRect l="11452" t="4151" b="71925"/>
            <a:stretch/>
          </p:blipFill>
          <p:spPr>
            <a:xfrm>
              <a:off x="912872" y="209276"/>
              <a:ext cx="4040128" cy="1506379"/>
            </a:xfrm>
            <a:prstGeom prst="rect">
              <a:avLst/>
            </a:prstGeom>
          </p:spPr>
        </p:pic>
        <p:pic>
          <p:nvPicPr>
            <p:cNvPr id="18" name="Grafik 17"/>
            <p:cNvPicPr>
              <a:picLocks noChangeAspect="1"/>
            </p:cNvPicPr>
            <p:nvPr/>
          </p:nvPicPr>
          <p:blipFill rotWithShape="1">
            <a:blip r:embed="rId2"/>
            <a:srcRect l="11452" t="52423"/>
            <a:stretch/>
          </p:blipFill>
          <p:spPr>
            <a:xfrm>
              <a:off x="912872" y="1740242"/>
              <a:ext cx="4040128" cy="2995704"/>
            </a:xfrm>
            <a:prstGeom prst="rect">
              <a:avLst/>
            </a:prstGeom>
          </p:spPr>
        </p:pic>
      </p:grpSp>
      <p:sp>
        <p:nvSpPr>
          <p:cNvPr id="19" name="Textfeld 18"/>
          <p:cNvSpPr txBox="1"/>
          <p:nvPr/>
        </p:nvSpPr>
        <p:spPr>
          <a:xfrm>
            <a:off x="609600" y="76200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65144" y="7534870"/>
            <a:ext cx="671665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9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luorescence staining of murine microglia SIM-A9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a)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′,6-diamidino-2-phenylindole (DAPI) (blue) is a nuclear marker and binds strongly to adenine–thymine-rich regions in the DNA. Iba1 (green) is expressed by microglia and circulating macrophages. The F-actin fibers are stained with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Phalloidin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Ph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 (gray), scale bar: 20µm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ma diameter 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90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ba1 fluorescence intensity expressed as corrected total fluorescence (CTFC). Stimulation with tumor necrosis factor alpha (TNF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r interferon gamma (IFN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ithout or with addition of 50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phytosterol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(PS). Statistics: Mann-Whitney-U-Test with p&lt;0.05*, p&lt;0.01**, p&lt;0.001***. </a:t>
            </a:r>
          </a:p>
        </p:txBody>
      </p:sp>
      <p:grpSp>
        <p:nvGrpSpPr>
          <p:cNvPr id="72" name="Gruppieren 71"/>
          <p:cNvGrpSpPr/>
          <p:nvPr/>
        </p:nvGrpSpPr>
        <p:grpSpPr>
          <a:xfrm>
            <a:off x="3272541" y="5236180"/>
            <a:ext cx="2506722" cy="2231420"/>
            <a:chOff x="3272541" y="5236180"/>
            <a:chExt cx="2506722" cy="2231420"/>
          </a:xfrm>
        </p:grpSpPr>
        <p:sp>
          <p:nvSpPr>
            <p:cNvPr id="20" name="Textfeld 19"/>
            <p:cNvSpPr txBox="1"/>
            <p:nvPr/>
          </p:nvSpPr>
          <p:spPr>
            <a:xfrm>
              <a:off x="3272541" y="5236180"/>
              <a:ext cx="28084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1" name="Gruppieren 70"/>
            <p:cNvGrpSpPr/>
            <p:nvPr/>
          </p:nvGrpSpPr>
          <p:grpSpPr>
            <a:xfrm>
              <a:off x="4929170" y="5715000"/>
              <a:ext cx="252000" cy="253916"/>
              <a:chOff x="4929170" y="5715000"/>
              <a:chExt cx="252000" cy="253916"/>
            </a:xfrm>
          </p:grpSpPr>
          <p:cxnSp>
            <p:nvCxnSpPr>
              <p:cNvPr id="38" name="Gerade Verbindung 24"/>
              <p:cNvCxnSpPr/>
              <p:nvPr/>
            </p:nvCxnSpPr>
            <p:spPr>
              <a:xfrm>
                <a:off x="4929170" y="5868360"/>
                <a:ext cx="25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feld 38"/>
              <p:cNvSpPr txBox="1"/>
              <p:nvPr/>
            </p:nvSpPr>
            <p:spPr>
              <a:xfrm>
                <a:off x="4958206" y="5715000"/>
                <a:ext cx="19392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pic>
          <p:nvPicPr>
            <p:cNvPr id="44" name="Grafik 4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52800" y="5487600"/>
              <a:ext cx="2426463" cy="1980000"/>
            </a:xfrm>
            <a:prstGeom prst="rect">
              <a:avLst/>
            </a:prstGeom>
          </p:spPr>
        </p:pic>
      </p:grpSp>
      <p:grpSp>
        <p:nvGrpSpPr>
          <p:cNvPr id="78" name="Gruppieren 77"/>
          <p:cNvGrpSpPr/>
          <p:nvPr/>
        </p:nvGrpSpPr>
        <p:grpSpPr>
          <a:xfrm>
            <a:off x="615457" y="5236180"/>
            <a:ext cx="2661143" cy="2231420"/>
            <a:chOff x="615457" y="5236180"/>
            <a:chExt cx="2661143" cy="2231420"/>
          </a:xfrm>
        </p:grpSpPr>
        <p:grpSp>
          <p:nvGrpSpPr>
            <p:cNvPr id="52" name="Gruppieren 51"/>
            <p:cNvGrpSpPr/>
            <p:nvPr/>
          </p:nvGrpSpPr>
          <p:grpSpPr>
            <a:xfrm>
              <a:off x="1501539" y="5361639"/>
              <a:ext cx="1188000" cy="253916"/>
              <a:chOff x="1497400" y="5410200"/>
              <a:chExt cx="1188000" cy="253916"/>
            </a:xfrm>
          </p:grpSpPr>
          <p:cxnSp>
            <p:nvCxnSpPr>
              <p:cNvPr id="22" name="Gerade Verbindung 41"/>
              <p:cNvCxnSpPr/>
              <p:nvPr/>
            </p:nvCxnSpPr>
            <p:spPr>
              <a:xfrm>
                <a:off x="1497400" y="5562600"/>
                <a:ext cx="118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feld 22"/>
              <p:cNvSpPr txBox="1"/>
              <p:nvPr/>
            </p:nvSpPr>
            <p:spPr>
              <a:xfrm>
                <a:off x="1936267" y="5410200"/>
                <a:ext cx="29046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1" name="Textfeld 40"/>
            <p:cNvSpPr txBox="1"/>
            <p:nvPr/>
          </p:nvSpPr>
          <p:spPr>
            <a:xfrm>
              <a:off x="615457" y="5236180"/>
              <a:ext cx="290464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7" name="Grafik 4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06020" y="5451600"/>
              <a:ext cx="2470580" cy="2016000"/>
            </a:xfrm>
            <a:prstGeom prst="rect">
              <a:avLst/>
            </a:prstGeom>
          </p:spPr>
        </p:pic>
        <p:grpSp>
          <p:nvGrpSpPr>
            <p:cNvPr id="54" name="Gruppieren 53"/>
            <p:cNvGrpSpPr/>
            <p:nvPr/>
          </p:nvGrpSpPr>
          <p:grpSpPr>
            <a:xfrm>
              <a:off x="1789539" y="5490794"/>
              <a:ext cx="900000" cy="224206"/>
              <a:chOff x="1789539" y="5979448"/>
              <a:chExt cx="900000" cy="224206"/>
            </a:xfrm>
          </p:grpSpPr>
          <p:cxnSp>
            <p:nvCxnSpPr>
              <p:cNvPr id="50" name="Gerade Verbindung 41"/>
              <p:cNvCxnSpPr/>
              <p:nvPr/>
            </p:nvCxnSpPr>
            <p:spPr>
              <a:xfrm>
                <a:off x="1789539" y="6131848"/>
                <a:ext cx="90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feld 50"/>
              <p:cNvSpPr txBox="1"/>
              <p:nvPr/>
            </p:nvSpPr>
            <p:spPr>
              <a:xfrm>
                <a:off x="2087945" y="5979448"/>
                <a:ext cx="303188" cy="2242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77" name="Gruppieren 76"/>
            <p:cNvGrpSpPr/>
            <p:nvPr/>
          </p:nvGrpSpPr>
          <p:grpSpPr>
            <a:xfrm>
              <a:off x="1805653" y="5613484"/>
              <a:ext cx="1215573" cy="253916"/>
              <a:chOff x="1805653" y="5613484"/>
              <a:chExt cx="1215573" cy="253916"/>
            </a:xfrm>
          </p:grpSpPr>
          <p:grpSp>
            <p:nvGrpSpPr>
              <p:cNvPr id="75" name="Gruppieren 74"/>
              <p:cNvGrpSpPr/>
              <p:nvPr/>
            </p:nvGrpSpPr>
            <p:grpSpPr>
              <a:xfrm>
                <a:off x="2119494" y="5613484"/>
                <a:ext cx="252000" cy="253916"/>
                <a:chOff x="2133600" y="5613484"/>
                <a:chExt cx="252000" cy="253916"/>
              </a:xfrm>
            </p:grpSpPr>
            <p:cxnSp>
              <p:nvCxnSpPr>
                <p:cNvPr id="56" name="Gerade Verbindung 24"/>
                <p:cNvCxnSpPr/>
                <p:nvPr/>
              </p:nvCxnSpPr>
              <p:spPr>
                <a:xfrm>
                  <a:off x="2133600" y="5768816"/>
                  <a:ext cx="25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Textfeld 56"/>
                <p:cNvSpPr txBox="1"/>
                <p:nvPr/>
              </p:nvSpPr>
              <p:spPr>
                <a:xfrm>
                  <a:off x="2162636" y="5613484"/>
                  <a:ext cx="193928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73" name="Gruppieren 72"/>
              <p:cNvGrpSpPr/>
              <p:nvPr/>
            </p:nvGrpSpPr>
            <p:grpSpPr>
              <a:xfrm>
                <a:off x="2317432" y="5613484"/>
                <a:ext cx="462181" cy="253916"/>
                <a:chOff x="2318683" y="5613484"/>
                <a:chExt cx="462181" cy="253916"/>
              </a:xfrm>
            </p:grpSpPr>
            <p:cxnSp>
              <p:nvCxnSpPr>
                <p:cNvPr id="63" name="Gerade Verbindung 24"/>
                <p:cNvCxnSpPr/>
                <p:nvPr/>
              </p:nvCxnSpPr>
              <p:spPr>
                <a:xfrm>
                  <a:off x="2423773" y="5768815"/>
                  <a:ext cx="25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Textfeld 63"/>
                <p:cNvSpPr txBox="1"/>
                <p:nvPr/>
              </p:nvSpPr>
              <p:spPr>
                <a:xfrm>
                  <a:off x="2318683" y="5613484"/>
                  <a:ext cx="462181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**</a:t>
                  </a:r>
                  <a:endParaRPr lang="en-US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4" name="Gruppieren 73"/>
              <p:cNvGrpSpPr/>
              <p:nvPr/>
            </p:nvGrpSpPr>
            <p:grpSpPr>
              <a:xfrm>
                <a:off x="1805653" y="5613484"/>
                <a:ext cx="252000" cy="253916"/>
                <a:chOff x="1805400" y="5613484"/>
                <a:chExt cx="252000" cy="253916"/>
              </a:xfrm>
            </p:grpSpPr>
            <p:cxnSp>
              <p:nvCxnSpPr>
                <p:cNvPr id="66" name="Gerade Verbindung 24"/>
                <p:cNvCxnSpPr/>
                <p:nvPr/>
              </p:nvCxnSpPr>
              <p:spPr>
                <a:xfrm>
                  <a:off x="1805400" y="5768816"/>
                  <a:ext cx="25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" name="Textfeld 66"/>
                <p:cNvSpPr txBox="1"/>
                <p:nvPr/>
              </p:nvSpPr>
              <p:spPr>
                <a:xfrm>
                  <a:off x="1834436" y="5613484"/>
                  <a:ext cx="193928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76" name="Gruppieren 75"/>
              <p:cNvGrpSpPr/>
              <p:nvPr/>
            </p:nvGrpSpPr>
            <p:grpSpPr>
              <a:xfrm>
                <a:off x="2711445" y="5613484"/>
                <a:ext cx="309781" cy="253916"/>
                <a:chOff x="2738219" y="5613484"/>
                <a:chExt cx="309781" cy="253916"/>
              </a:xfrm>
            </p:grpSpPr>
            <p:cxnSp>
              <p:nvCxnSpPr>
                <p:cNvPr id="69" name="Gerade Verbindung 24"/>
                <p:cNvCxnSpPr/>
                <p:nvPr/>
              </p:nvCxnSpPr>
              <p:spPr>
                <a:xfrm>
                  <a:off x="2767109" y="5768815"/>
                  <a:ext cx="25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0" name="Textfeld 69"/>
                <p:cNvSpPr txBox="1"/>
                <p:nvPr/>
              </p:nvSpPr>
              <p:spPr>
                <a:xfrm>
                  <a:off x="2738219" y="5613484"/>
                  <a:ext cx="309781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12600483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1</Words>
  <Application>Microsoft Office PowerPoint</Application>
  <PresentationFormat>Bildschirmpräsentation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34</cp:revision>
  <dcterms:created xsi:type="dcterms:W3CDTF">2020-05-26T14:19:15Z</dcterms:created>
  <dcterms:modified xsi:type="dcterms:W3CDTF">2021-11-08T14:24:27Z</dcterms:modified>
</cp:coreProperties>
</file>